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7511D4-CDE1-456E-A29D-2068A2B76CFB}"/>
              </a:ext>
            </a:extLst>
          </p:cNvPr>
          <p:cNvSpPr txBox="1"/>
          <p:nvPr/>
        </p:nvSpPr>
        <p:spPr>
          <a:xfrm>
            <a:off x="492830" y="432000"/>
            <a:ext cx="6022931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/>
              <a:t>S4 FIGURE </a:t>
            </a:r>
            <a:r>
              <a:rPr lang="en-US" sz="1100" b="1" dirty="0"/>
              <a:t>4 | A) </a:t>
            </a:r>
            <a:r>
              <a:rPr lang="en-US" sz="1100" dirty="0"/>
              <a:t>PRM chromatograms of SARS-CoV-2 Nucleocapsid and VME1 tryptic peptides </a:t>
            </a:r>
            <a:r>
              <a:rPr lang="en-US" sz="1100" u="sng" dirty="0"/>
              <a:t>AYNVTQAFGR</a:t>
            </a:r>
            <a:r>
              <a:rPr lang="en-US" sz="1100" dirty="0"/>
              <a:t> and </a:t>
            </a:r>
            <a:r>
              <a:rPr lang="en-US" sz="1100" u="sng" dirty="0"/>
              <a:t>VAGDSFAAYSR</a:t>
            </a:r>
            <a:r>
              <a:rPr lang="en-US" sz="1100" dirty="0"/>
              <a:t> in four additional COVID-19 patient sputum specimens (#s 3-6) and one specimen from a patient infected with influenza B serving as a negative control (# 3). Chromatograms for each of the Top6 fragment ions are shown in different colors. The upper panels show the fragment ion chromatograms of the corresponding synthetic AQUA peptide </a:t>
            </a:r>
            <a:r>
              <a:rPr lang="en-US" sz="1100" u="sng" dirty="0"/>
              <a:t>AYNVTQAFG[R]</a:t>
            </a:r>
            <a:r>
              <a:rPr lang="en-US" sz="1100" dirty="0"/>
              <a:t> (</a:t>
            </a:r>
            <a:r>
              <a:rPr lang="en-US" sz="1100" i="1" dirty="0"/>
              <a:t>m/z</a:t>
            </a:r>
            <a:r>
              <a:rPr lang="en-US" sz="1100" dirty="0"/>
              <a:t> 568.79) and </a:t>
            </a:r>
            <a:r>
              <a:rPr lang="en-US" sz="1100" u="sng" dirty="0"/>
              <a:t>VAGDSFAAYS[R</a:t>
            </a:r>
            <a:r>
              <a:rPr lang="en-US" sz="1100" dirty="0"/>
              <a:t>] (</a:t>
            </a:r>
            <a:r>
              <a:rPr lang="en-US" sz="1100" i="1" dirty="0"/>
              <a:t>m/z</a:t>
            </a:r>
            <a:r>
              <a:rPr lang="en-US" sz="1100" dirty="0"/>
              <a:t> 605.79). Supplementary Table 3 contains the output in table format, including Skyline library dot product and total area fragment values. </a:t>
            </a:r>
            <a:r>
              <a:rPr lang="en-US" sz="1100" b="1" dirty="0"/>
              <a:t>B)</a:t>
            </a:r>
            <a:r>
              <a:rPr lang="en-US" sz="1100" dirty="0"/>
              <a:t> The corresponding Ct values for the sputum and throat swab samples from PCR assays. </a:t>
            </a:r>
            <a:endParaRPr lang="en-NL" sz="1100" dirty="0"/>
          </a:p>
          <a:p>
            <a:endParaRPr lang="en-NL" sz="1100" dirty="0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E53EEA8A-FF4C-41C9-9EA7-7CD076A2E163}"/>
              </a:ext>
            </a:extLst>
          </p:cNvPr>
          <p:cNvGrpSpPr>
            <a:grpSpLocks noChangeAspect="1"/>
          </p:cNvGrpSpPr>
          <p:nvPr/>
        </p:nvGrpSpPr>
        <p:grpSpPr>
          <a:xfrm>
            <a:off x="189605" y="2465671"/>
            <a:ext cx="6477648" cy="3799227"/>
            <a:chOff x="-885512" y="3644727"/>
            <a:chExt cx="9994169" cy="5861713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7FE2A5B6-8EBD-4A1F-AB8E-CCC0618C95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9" t="274" r="24854" b="70382"/>
            <a:stretch/>
          </p:blipFill>
          <p:spPr>
            <a:xfrm>
              <a:off x="-766758" y="3692854"/>
              <a:ext cx="5022681" cy="2906793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9AD635DD-F4DC-4CC3-92F4-A6659F2AE4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622" b="70656"/>
            <a:stretch/>
          </p:blipFill>
          <p:spPr>
            <a:xfrm>
              <a:off x="4085976" y="3644727"/>
              <a:ext cx="5022681" cy="2906793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3470F74F-5AD6-4208-8DF8-8B0A585BDF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622" b="70656"/>
            <a:stretch/>
          </p:blipFill>
          <p:spPr>
            <a:xfrm>
              <a:off x="4068171" y="6567560"/>
              <a:ext cx="5022681" cy="2906793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291DA87-D383-4987-8C78-0D00C2EBEE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622" b="70656"/>
            <a:stretch/>
          </p:blipFill>
          <p:spPr>
            <a:xfrm>
              <a:off x="-885512" y="6599647"/>
              <a:ext cx="5022680" cy="2906793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5255601A-B908-40B1-9BB7-14A35F4CF493}"/>
              </a:ext>
            </a:extLst>
          </p:cNvPr>
          <p:cNvSpPr txBox="1"/>
          <p:nvPr/>
        </p:nvSpPr>
        <p:spPr>
          <a:xfrm>
            <a:off x="491319" y="2089978"/>
            <a:ext cx="451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)</a:t>
            </a:r>
            <a:endParaRPr lang="en-US" sz="11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C677328-5AEB-4633-922A-2519CFEA887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19" b="70930"/>
          <a:stretch/>
        </p:blipFill>
        <p:spPr>
          <a:xfrm>
            <a:off x="180617" y="6285694"/>
            <a:ext cx="3219682" cy="18739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AB9091D-E35D-4A17-A7E4-DD1F729E61DA}"/>
              </a:ext>
            </a:extLst>
          </p:cNvPr>
          <p:cNvSpPr txBox="1"/>
          <p:nvPr/>
        </p:nvSpPr>
        <p:spPr>
          <a:xfrm>
            <a:off x="514806" y="6391205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Negative 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08BA16E-22EA-4263-B732-6FA73CB39087}"/>
              </a:ext>
            </a:extLst>
          </p:cNvPr>
          <p:cNvSpPr txBox="1"/>
          <p:nvPr/>
        </p:nvSpPr>
        <p:spPr>
          <a:xfrm>
            <a:off x="2102602" y="639206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Negative control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3CA21D8-0A0C-4406-BE8E-F7AB5A4074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11743" y="6673212"/>
            <a:ext cx="2534583" cy="124843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19542D2-DDE7-412E-B917-B08159AA85F3}"/>
              </a:ext>
            </a:extLst>
          </p:cNvPr>
          <p:cNvSpPr txBox="1"/>
          <p:nvPr/>
        </p:nvSpPr>
        <p:spPr>
          <a:xfrm>
            <a:off x="3521989" y="6301985"/>
            <a:ext cx="451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)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406242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1</TotalTime>
  <Words>142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4</cp:revision>
  <dcterms:created xsi:type="dcterms:W3CDTF">2020-04-19T12:14:45Z</dcterms:created>
  <dcterms:modified xsi:type="dcterms:W3CDTF">2021-07-15T09:36:06Z</dcterms:modified>
</cp:coreProperties>
</file>